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th-TH"/>
    </a:defPPr>
    <a:lvl1pPr marL="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4660"/>
  </p:normalViewPr>
  <p:slideViewPr>
    <p:cSldViewPr snapToGrid="0">
      <p:cViewPr varScale="1">
        <p:scale>
          <a:sx n="74" d="100"/>
          <a:sy n="74" d="100"/>
        </p:scale>
        <p:origin x="340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สไลด์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BE75EFD8-AA92-AF9E-95DC-0CC26CAE073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ชื่อเรื่องรอง 2">
            <a:extLst>
              <a:ext uri="{FF2B5EF4-FFF2-40B4-BE49-F238E27FC236}">
                <a16:creationId xmlns:a16="http://schemas.microsoft.com/office/drawing/2014/main" id="{57BA52DC-A00B-99DE-477D-0A0D5B48E08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th-TH"/>
              <a:t>คลิกเพื่อแก้ไขสไตล์ชื่อเรื่องรองต้นแบบ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313382CE-2245-FEAF-8482-B45C5CE832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C369B5-6930-4E6D-BB04-F8D27847F52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18A50B90-BDF0-EDD2-851D-CA0FCD7485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DD7BFC4C-FC04-EDD8-7CCA-05ACF0EDF7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5F5E9-F080-41D4-8409-40F87844396F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3488137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ชื่อเรื่องและข้อความ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49D089E5-8393-CB6B-C61F-A98BBC2EFD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แนวตั้ง 2">
            <a:extLst>
              <a:ext uri="{FF2B5EF4-FFF2-40B4-BE49-F238E27FC236}">
                <a16:creationId xmlns:a16="http://schemas.microsoft.com/office/drawing/2014/main" id="{F354BD8A-0B0C-7078-9EBA-B9326C1432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F67C1816-0357-B62F-4B7E-A82D20E2C7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C369B5-6930-4E6D-BB04-F8D27847F52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1D98DB4C-6D6B-37FA-FEB7-5A7A5E67C2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852B647F-EA6B-40EA-1E41-45F88A7E56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5F5E9-F080-41D4-8409-40F87844396F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4044604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ข้อความและชื่อเรื่อง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แนวตั้ง 1">
            <a:extLst>
              <a:ext uri="{FF2B5EF4-FFF2-40B4-BE49-F238E27FC236}">
                <a16:creationId xmlns:a16="http://schemas.microsoft.com/office/drawing/2014/main" id="{B4E39780-CC56-86D9-5585-F14CCDF940D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แนวตั้ง 2">
            <a:extLst>
              <a:ext uri="{FF2B5EF4-FFF2-40B4-BE49-F238E27FC236}">
                <a16:creationId xmlns:a16="http://schemas.microsoft.com/office/drawing/2014/main" id="{5492590E-A657-A041-2A8A-DCF0F9A066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250F8685-B4EB-7186-A5A2-BCD6BDB759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C369B5-6930-4E6D-BB04-F8D27847F52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292197F3-C211-2ADF-30FA-91034AEBC3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90CE79F6-4CD8-B45C-6300-9AA7E2C662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5F5E9-F080-41D4-8409-40F87844396F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0494975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ชื่อเรื่องและเนื้อห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9ED513C0-C9BE-ABA7-CD21-D26951A3B3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E7079195-D1CD-5EE7-2C94-1AAC31F9CD5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3E68C518-D340-1011-42D6-A0AC287C3C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C369B5-6930-4E6D-BB04-F8D27847F52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9128936B-AF9A-941D-39D2-E5C670284B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52647B83-5B61-B804-0314-B57C3AD3CA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5F5E9-F080-41D4-8409-40F87844396F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4398223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ส่วนหัวของ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66455382-B374-64CA-29F9-FDE76AFB79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67A9DF1A-A80A-2229-40E7-FBBE5A97AC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DA842675-1EC0-DA89-DFE9-D1E15980BD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C369B5-6930-4E6D-BB04-F8D27847F52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D7DB1F8B-FA5A-B776-A13D-E04DD2080E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D5BD1C35-2FBA-C125-D27E-E5629739B6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5F5E9-F080-41D4-8409-40F87844396F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5447906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เนื้อหา 2 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4EA7535C-9ED2-E203-42B7-BC656A72C2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FBDF8FF3-362B-A0B4-0401-EB3E367F7FA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เนื้อหา 3">
            <a:extLst>
              <a:ext uri="{FF2B5EF4-FFF2-40B4-BE49-F238E27FC236}">
                <a16:creationId xmlns:a16="http://schemas.microsoft.com/office/drawing/2014/main" id="{EEBDA849-C3EE-32AE-C24C-BA2D9B34DD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DE18B44C-484D-EDDC-1C03-5266DB0131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C369B5-6930-4E6D-BB04-F8D27847F52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4B4C209A-AE97-C54E-0E3A-3905C4ADC1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5C14A393-6156-F891-5701-0D5051D851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5F5E9-F080-41D4-8409-40F87844396F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8843695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การเปรียบเทียบ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D55D5E10-5462-2901-9388-ECACC3FCF3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F9E425CF-60D3-6096-FD4E-103DDF3AB2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4" name="ตัวแทนเนื้อหา 3">
            <a:extLst>
              <a:ext uri="{FF2B5EF4-FFF2-40B4-BE49-F238E27FC236}">
                <a16:creationId xmlns:a16="http://schemas.microsoft.com/office/drawing/2014/main" id="{DF5EF600-870E-0CE5-38D8-FDA85CB685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5" name="ตัวแทนข้อความ 4">
            <a:extLst>
              <a:ext uri="{FF2B5EF4-FFF2-40B4-BE49-F238E27FC236}">
                <a16:creationId xmlns:a16="http://schemas.microsoft.com/office/drawing/2014/main" id="{11BBE072-970E-96CC-B364-7E161FA8FF5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6" name="ตัวแทนเนื้อหา 5">
            <a:extLst>
              <a:ext uri="{FF2B5EF4-FFF2-40B4-BE49-F238E27FC236}">
                <a16:creationId xmlns:a16="http://schemas.microsoft.com/office/drawing/2014/main" id="{53C5CAFA-260A-1212-FAA0-3EBC1D779EC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7" name="ตัวแทนวันที่ 6">
            <a:extLst>
              <a:ext uri="{FF2B5EF4-FFF2-40B4-BE49-F238E27FC236}">
                <a16:creationId xmlns:a16="http://schemas.microsoft.com/office/drawing/2014/main" id="{147A6C87-D5A0-B1BD-534E-5ED1500697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C369B5-6930-4E6D-BB04-F8D27847F52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8" name="ตัวแทนท้ายกระดาษ 7">
            <a:extLst>
              <a:ext uri="{FF2B5EF4-FFF2-40B4-BE49-F238E27FC236}">
                <a16:creationId xmlns:a16="http://schemas.microsoft.com/office/drawing/2014/main" id="{4999D3BE-874D-337A-0842-34680634C8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9" name="ตัวแทนหมายเลขสไลด์ 8">
            <a:extLst>
              <a:ext uri="{FF2B5EF4-FFF2-40B4-BE49-F238E27FC236}">
                <a16:creationId xmlns:a16="http://schemas.microsoft.com/office/drawing/2014/main" id="{A98FB5D7-DF10-E3E8-A864-1CAC03FC3E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5F5E9-F080-41D4-8409-40F87844396F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6604290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เฉพาะ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9C63512B-F9D5-11ED-3508-BA654B0830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วันที่ 2">
            <a:extLst>
              <a:ext uri="{FF2B5EF4-FFF2-40B4-BE49-F238E27FC236}">
                <a16:creationId xmlns:a16="http://schemas.microsoft.com/office/drawing/2014/main" id="{6F173EC8-3AB0-553A-1864-2A3514F2A4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C369B5-6930-4E6D-BB04-F8D27847F52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4" name="ตัวแทนท้ายกระดาษ 3">
            <a:extLst>
              <a:ext uri="{FF2B5EF4-FFF2-40B4-BE49-F238E27FC236}">
                <a16:creationId xmlns:a16="http://schemas.microsoft.com/office/drawing/2014/main" id="{DE6D3B1A-B947-9D23-F179-81383FF310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5" name="ตัวแทนหมายเลขสไลด์ 4">
            <a:extLst>
              <a:ext uri="{FF2B5EF4-FFF2-40B4-BE49-F238E27FC236}">
                <a16:creationId xmlns:a16="http://schemas.microsoft.com/office/drawing/2014/main" id="{EC8491C7-C8F2-5B67-061A-E58DC6E231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5F5E9-F080-41D4-8409-40F87844396F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6660316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ว่างเปล่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ตัวแทนวันที่ 1">
            <a:extLst>
              <a:ext uri="{FF2B5EF4-FFF2-40B4-BE49-F238E27FC236}">
                <a16:creationId xmlns:a16="http://schemas.microsoft.com/office/drawing/2014/main" id="{EE8317B7-9489-4C34-A5F6-1A3542DC3B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C369B5-6930-4E6D-BB04-F8D27847F52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3" name="ตัวแทนท้ายกระดาษ 2">
            <a:extLst>
              <a:ext uri="{FF2B5EF4-FFF2-40B4-BE49-F238E27FC236}">
                <a16:creationId xmlns:a16="http://schemas.microsoft.com/office/drawing/2014/main" id="{5CC7D4F7-B54A-CE4D-3CE2-ACAE4F9D1D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4" name="ตัวแทนหมายเลขสไลด์ 3">
            <a:extLst>
              <a:ext uri="{FF2B5EF4-FFF2-40B4-BE49-F238E27FC236}">
                <a16:creationId xmlns:a16="http://schemas.microsoft.com/office/drawing/2014/main" id="{C4E5132E-3052-1B16-8C25-B259CBD530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5F5E9-F080-41D4-8409-40F87844396F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0622472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เนื้อหา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C93A426C-DC50-715E-6457-F67C342CCF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A745033C-5275-F98A-FAA3-335EEA919F0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ข้อความ 3">
            <a:extLst>
              <a:ext uri="{FF2B5EF4-FFF2-40B4-BE49-F238E27FC236}">
                <a16:creationId xmlns:a16="http://schemas.microsoft.com/office/drawing/2014/main" id="{4177BAF6-6093-CD2E-F008-4F0B7472F49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0D27CF57-6ADC-14E9-B552-53756651A8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C369B5-6930-4E6D-BB04-F8D27847F52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BAE7431C-99F2-0DF7-832F-4072B3309C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69AAD377-A019-25CE-14EC-76FED2F3C4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5F5E9-F080-41D4-8409-40F87844396F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651834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รูปภาพ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2FD2A6B0-43A2-73C9-2CCC-50EB74BFB0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รูปภาพ 2">
            <a:extLst>
              <a:ext uri="{FF2B5EF4-FFF2-40B4-BE49-F238E27FC236}">
                <a16:creationId xmlns:a16="http://schemas.microsoft.com/office/drawing/2014/main" id="{934F71C5-90A3-9CD7-2C02-BE1EC9CFDBF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th-TH"/>
          </a:p>
        </p:txBody>
      </p:sp>
      <p:sp>
        <p:nvSpPr>
          <p:cNvPr id="4" name="ตัวแทนข้อความ 3">
            <a:extLst>
              <a:ext uri="{FF2B5EF4-FFF2-40B4-BE49-F238E27FC236}">
                <a16:creationId xmlns:a16="http://schemas.microsoft.com/office/drawing/2014/main" id="{C04578B1-7CF5-EB93-648A-A42E6FB103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71E30639-60A7-6E22-418B-DF75BB24B2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C369B5-6930-4E6D-BB04-F8D27847F52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44CC3ED4-2CD0-CD7C-8978-C6C8A5AD55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6254385E-A8A5-097F-E236-D278345A2D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5F5E9-F080-41D4-8409-40F87844396F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436515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ตัวแทนชื่อเรื่อง 1">
            <a:extLst>
              <a:ext uri="{FF2B5EF4-FFF2-40B4-BE49-F238E27FC236}">
                <a16:creationId xmlns:a16="http://schemas.microsoft.com/office/drawing/2014/main" id="{914E7827-F28C-F174-FC3E-79614922FD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B0590D9F-8A2B-CE58-598A-8BCE28CBA1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8836A7E9-5F4A-9EC0-A3A8-FC9757742A9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C369B5-6930-4E6D-BB04-F8D27847F52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D8C2F94D-A686-947C-D2A8-682E8F4BEB8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0CDA9458-5743-0623-41AA-E21451E637E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05F5E9-F080-41D4-8409-40F87844396F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40324135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h-TH"/>
      </a:defPPr>
      <a:lvl1pPr marL="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รูปภาพ 1">
            <a:extLst>
              <a:ext uri="{FF2B5EF4-FFF2-40B4-BE49-F238E27FC236}">
                <a16:creationId xmlns:a16="http://schemas.microsoft.com/office/drawing/2014/main" id="{1FD760F0-1D7A-66AD-2C54-6B7F052160D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76398" y="1620329"/>
            <a:ext cx="8113588" cy="3020682"/>
          </a:xfrm>
          <a:prstGeom prst="rect">
            <a:avLst/>
          </a:prstGeom>
          <a:noFill/>
        </p:spPr>
      </p:pic>
      <p:sp>
        <p:nvSpPr>
          <p:cNvPr id="4" name="กล่องข้อความ 3">
            <a:extLst>
              <a:ext uri="{FF2B5EF4-FFF2-40B4-BE49-F238E27FC236}">
                <a16:creationId xmlns:a16="http://schemas.microsoft.com/office/drawing/2014/main" id="{E9258D56-ADBB-BC85-565E-59FA6E98BFCB}"/>
              </a:ext>
            </a:extLst>
          </p:cNvPr>
          <p:cNvSpPr txBox="1"/>
          <p:nvPr/>
        </p:nvSpPr>
        <p:spPr>
          <a:xfrm>
            <a:off x="1817213" y="4759783"/>
            <a:ext cx="9831957" cy="4778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buNone/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Supplementary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 Figure S15. MS/MS spectrum of Astragalin (kaempferol-3-O-glucoside) showing characteristic fragment ions derived from glycosidic bond cleavage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932033531"/>
      </p:ext>
    </p:extLst>
  </p:cSld>
  <p:clrMapOvr>
    <a:masterClrMapping/>
  </p:clrMapOvr>
</p:sld>
</file>

<file path=ppt/theme/theme1.xml><?xml version="1.0" encoding="utf-8"?>
<a:theme xmlns:a="http://schemas.openxmlformats.org/drawingml/2006/main" name="ธีมของ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</Words>
  <Application>Microsoft Office PowerPoint</Application>
  <PresentationFormat>แบบจอกว้าง</PresentationFormat>
  <Paragraphs>1</Paragraphs>
  <Slides>1</Slides>
  <Notes>0</Notes>
  <HiddenSlides>0</HiddenSlides>
  <MMClips>0</MMClips>
  <ScaleCrop>false</ScaleCrop>
  <HeadingPairs>
    <vt:vector size="6" baseType="variant">
      <vt:variant>
        <vt:lpstr>ฟอนต์ที่ถูกใช้</vt:lpstr>
      </vt:variant>
      <vt:variant>
        <vt:i4>4</vt:i4>
      </vt:variant>
      <vt:variant>
        <vt:lpstr>ธีม</vt:lpstr>
      </vt:variant>
      <vt:variant>
        <vt:i4>1</vt:i4>
      </vt:variant>
      <vt:variant>
        <vt:lpstr>ชื่อเรื่องสไลด์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ธีมของ Office</vt:lpstr>
      <vt:lpstr>งานนำเสนอ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กิ่งกาญจน์ บรรลือพืช</dc:creator>
  <cp:lastModifiedBy>กิ่งกาญจน์ บรรลือพืช</cp:lastModifiedBy>
  <cp:revision>1</cp:revision>
  <dcterms:created xsi:type="dcterms:W3CDTF">2026-02-22T09:17:42Z</dcterms:created>
  <dcterms:modified xsi:type="dcterms:W3CDTF">2026-02-22T09:17:55Z</dcterms:modified>
</cp:coreProperties>
</file>